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9743" autoAdjust="0"/>
  </p:normalViewPr>
  <p:slideViewPr>
    <p:cSldViewPr snapToGrid="0">
      <p:cViewPr>
        <p:scale>
          <a:sx n="75" d="100"/>
          <a:sy n="75" d="100"/>
        </p:scale>
        <p:origin x="1896" y="9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350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0922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3522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7047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9276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9454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0642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262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2460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3200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0717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C36D5-C26C-4360-A8AD-E6D025DEF1C0}" type="datetimeFigureOut">
              <a:rPr lang="de-DE" smtClean="0"/>
              <a:t>17.09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2C1D1-396B-4387-8693-1FDA852F231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8486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9" Type="http://schemas.openxmlformats.org/officeDocument/2006/relationships/image" Target="../media/image38.png"/><Relationship Id="rId3" Type="http://schemas.openxmlformats.org/officeDocument/2006/relationships/image" Target="../media/image2.png"/><Relationship Id="rId21" Type="http://schemas.openxmlformats.org/officeDocument/2006/relationships/image" Target="../media/image20.jpe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47" Type="http://schemas.openxmlformats.org/officeDocument/2006/relationships/image" Target="../media/image46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46" Type="http://schemas.openxmlformats.org/officeDocument/2006/relationships/image" Target="../media/image45.png"/><Relationship Id="rId2" Type="http://schemas.openxmlformats.org/officeDocument/2006/relationships/image" Target="../media/image1.jpeg"/><Relationship Id="rId16" Type="http://schemas.openxmlformats.org/officeDocument/2006/relationships/image" Target="../media/image15.png"/><Relationship Id="rId20" Type="http://schemas.openxmlformats.org/officeDocument/2006/relationships/image" Target="../media/image19.jpeg"/><Relationship Id="rId29" Type="http://schemas.openxmlformats.org/officeDocument/2006/relationships/image" Target="../media/image28.png"/><Relationship Id="rId41" Type="http://schemas.openxmlformats.org/officeDocument/2006/relationships/image" Target="../media/image4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png"/><Relationship Id="rId32" Type="http://schemas.openxmlformats.org/officeDocument/2006/relationships/image" Target="../media/image31.jpeg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45" Type="http://schemas.openxmlformats.org/officeDocument/2006/relationships/image" Target="../media/image44.pn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png"/><Relationship Id="rId28" Type="http://schemas.openxmlformats.org/officeDocument/2006/relationships/image" Target="../media/image27.jpeg"/><Relationship Id="rId36" Type="http://schemas.openxmlformats.org/officeDocument/2006/relationships/image" Target="../media/image35.pn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4" Type="http://schemas.openxmlformats.org/officeDocument/2006/relationships/image" Target="../media/image43.pn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png"/><Relationship Id="rId35" Type="http://schemas.openxmlformats.org/officeDocument/2006/relationships/image" Target="../media/image34.jpeg"/><Relationship Id="rId43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uppieren 15"/>
          <p:cNvGrpSpPr/>
          <p:nvPr/>
        </p:nvGrpSpPr>
        <p:grpSpPr>
          <a:xfrm>
            <a:off x="271490" y="99268"/>
            <a:ext cx="11687148" cy="6539205"/>
            <a:chOff x="271490" y="99268"/>
            <a:chExt cx="11687148" cy="6539205"/>
          </a:xfrm>
        </p:grpSpPr>
        <p:pic>
          <p:nvPicPr>
            <p:cNvPr id="5" name="Picture 2" descr="S:\Martin\Gewebekultur_Projekt_bessereOrdnung\Bilder\N18.C6\N18.C6_EVG_T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9356" y="1721024"/>
              <a:ext cx="1621455" cy="160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7" name="Grafik 20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1456" y="5002904"/>
              <a:ext cx="1621194" cy="1437194"/>
            </a:xfrm>
            <a:prstGeom prst="rect">
              <a:avLst/>
            </a:prstGeom>
          </p:spPr>
        </p:pic>
        <p:pic>
          <p:nvPicPr>
            <p:cNvPr id="208" name="Grafik 20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57059" y="6078380"/>
              <a:ext cx="971900" cy="547200"/>
            </a:xfrm>
            <a:prstGeom prst="rect">
              <a:avLst/>
            </a:prstGeom>
          </p:spPr>
        </p:pic>
        <p:pic>
          <p:nvPicPr>
            <p:cNvPr id="6" name="Picture 2" descr="S:\Martin\Gewebekultur_Projekt_bessereOrdnung\Bilder\N18.C6\N18.C6_ki67_T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9356" y="3356549"/>
              <a:ext cx="1621455" cy="160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3879" y="380181"/>
              <a:ext cx="1610986" cy="1288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3955" y="383186"/>
              <a:ext cx="1610986" cy="12886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4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6"/>
            <a:stretch>
              <a:fillRect/>
            </a:stretch>
          </p:blipFill>
          <p:spPr bwMode="auto">
            <a:xfrm>
              <a:off x="3282092" y="1181812"/>
              <a:ext cx="512849" cy="47435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2170530" y="1572858"/>
              <a:ext cx="499149" cy="91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Picture 3" descr="S:\Martin\Gewebekultur_Projekt_bessereOrdnung\Bilder\BCE6_Therapie\Pat6_N18_C6\Oxahigh\Oxa_high_EVG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3955" y="1717283"/>
              <a:ext cx="1616963" cy="16032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2" descr="S:\Martin\Gewebekultur_Projekt_bessereOrdnung\Bilder\BCE6_Therapie\Pat6_N18_C6\Oxahigh\Oxa_high_ki67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3955" y="3358842"/>
              <a:ext cx="1616963" cy="160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0601" y="361250"/>
              <a:ext cx="1607879" cy="1311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2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28623" y="1172388"/>
              <a:ext cx="498632" cy="47435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1" name="Picture 2" descr="S:\Martin\Gewebekultur_Projekt_bessereOrdnung\Bilder\BCE6_Therapie\Pat6_N18_C6\Oxalow\Oxa_low_EVG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0601" y="1713566"/>
              <a:ext cx="1607878" cy="160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2" descr="S:\Martin\Gewebekultur_Projekt_bessereOrdnung\Bilder\BCE6_Therapie\Pat6_N18_C6\Oxalow\Oxa_low_ki67.jpg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2104" y="3357165"/>
              <a:ext cx="1607878" cy="16049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" name="Picture 2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1561" y="350105"/>
              <a:ext cx="1603450" cy="1322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" name="Picture 2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68441" y="1180577"/>
              <a:ext cx="489582" cy="47435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26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5436058" y="1574065"/>
              <a:ext cx="499149" cy="91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2" descr="S:\Martin\Gewebekultur_Projekt_bessereOrdnung\Bilder\BCE6_Therapie\Pat6_N18_C6\Cethigh\Cet_high_EVG.jpg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6806" y="1711258"/>
              <a:ext cx="1597825" cy="1606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8" name="Picture 2" descr="S:\Martin\Gewebekultur_Projekt_bessereOrdnung\Bilder\BCE6_Therapie\Pat6_N18_C6\Cethigh\Cet_high_ki67.jpg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0044" y="3354160"/>
              <a:ext cx="1611118" cy="1601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3" name="Rechteck 66"/>
            <p:cNvSpPr>
              <a:spLocks noChangeArrowheads="1"/>
            </p:cNvSpPr>
            <p:nvPr/>
          </p:nvSpPr>
          <p:spPr bwMode="auto">
            <a:xfrm>
              <a:off x="2402240" y="135286"/>
              <a:ext cx="122982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Oxaliplatin 20 µM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34" name="Rechteck 67"/>
            <p:cNvSpPr>
              <a:spLocks noChangeArrowheads="1"/>
            </p:cNvSpPr>
            <p:nvPr/>
          </p:nvSpPr>
          <p:spPr bwMode="auto">
            <a:xfrm>
              <a:off x="4044894" y="125886"/>
              <a:ext cx="115929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Oxaliplatin 5 µM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35" name="Rechteck 68"/>
            <p:cNvSpPr>
              <a:spLocks noChangeArrowheads="1"/>
            </p:cNvSpPr>
            <p:nvPr/>
          </p:nvSpPr>
          <p:spPr bwMode="auto">
            <a:xfrm>
              <a:off x="5609902" y="108894"/>
              <a:ext cx="13067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Cetuximab 200 nM</a:t>
              </a:r>
            </a:p>
          </p:txBody>
        </p:sp>
        <p:sp>
          <p:nvSpPr>
            <p:cNvPr id="36" name="Rechteck 70"/>
            <p:cNvSpPr>
              <a:spLocks noChangeArrowheads="1"/>
            </p:cNvSpPr>
            <p:nvPr/>
          </p:nvSpPr>
          <p:spPr bwMode="auto">
            <a:xfrm>
              <a:off x="684441" y="121322"/>
              <a:ext cx="123783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 err="1">
                  <a:latin typeface="Arial" panose="020B0604020202020204" pitchFamily="34" charset="0"/>
                </a:rPr>
                <a:t>u</a:t>
              </a:r>
              <a:r>
                <a:rPr lang="de-DE" altLang="de-DE" sz="1000" b="1" dirty="0" err="1" smtClean="0">
                  <a:latin typeface="Arial" panose="020B0604020202020204" pitchFamily="34" charset="0"/>
                </a:rPr>
                <a:t>ntreated</a:t>
              </a:r>
              <a:r>
                <a:rPr lang="de-DE" altLang="de-DE" sz="1000" b="1" dirty="0" smtClean="0">
                  <a:latin typeface="Arial" panose="020B0604020202020204" pitchFamily="34" charset="0"/>
                </a:rPr>
                <a:t> </a:t>
              </a:r>
              <a:r>
                <a:rPr lang="de-DE" altLang="de-DE" sz="1000" b="1" dirty="0" err="1" smtClean="0">
                  <a:latin typeface="Arial" panose="020B0604020202020204" pitchFamily="34" charset="0"/>
                </a:rPr>
                <a:t>control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37" name="Rechteck 71"/>
            <p:cNvSpPr>
              <a:spLocks noChangeArrowheads="1"/>
            </p:cNvSpPr>
            <p:nvPr/>
          </p:nvSpPr>
          <p:spPr bwMode="auto">
            <a:xfrm rot="16200000">
              <a:off x="169275" y="893794"/>
              <a:ext cx="45557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H&amp;E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38" name="Rechteck 72"/>
            <p:cNvSpPr>
              <a:spLocks noChangeArrowheads="1"/>
            </p:cNvSpPr>
            <p:nvPr/>
          </p:nvSpPr>
          <p:spPr bwMode="auto">
            <a:xfrm rot="16200000">
              <a:off x="176059" y="2401028"/>
              <a:ext cx="43954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>
                  <a:latin typeface="Arial" panose="020B0604020202020204" pitchFamily="34" charset="0"/>
                </a:rPr>
                <a:t>EvG</a:t>
              </a:r>
              <a:endParaRPr lang="de-DE" altLang="de-DE" sz="1000" b="1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39" name="Rechteck 73"/>
            <p:cNvSpPr>
              <a:spLocks noChangeArrowheads="1"/>
            </p:cNvSpPr>
            <p:nvPr/>
          </p:nvSpPr>
          <p:spPr bwMode="auto">
            <a:xfrm rot="16200000">
              <a:off x="145975" y="4031631"/>
              <a:ext cx="49725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 smtClean="0">
                  <a:latin typeface="Arial" panose="020B0604020202020204" pitchFamily="34" charset="0"/>
                </a:rPr>
                <a:t>Ki-67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pic>
          <p:nvPicPr>
            <p:cNvPr id="40" name="Picture 2" descr="S:\Martin\Gewebekultur_Projekt_bessereOrdnung\Bilder\BCE6_Therapie\Pat6_N18_C6\Pemblow\Pemb_low_EVG.jpg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54338" y="1734341"/>
              <a:ext cx="1581274" cy="1579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7196257" y="1546397"/>
              <a:ext cx="502180" cy="91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2" name="Picture 4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30422" y="1552952"/>
              <a:ext cx="190120" cy="36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3" name="Picture 4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985122" y="1566064"/>
              <a:ext cx="190120" cy="36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4" name="Picture 4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97385" y="349743"/>
              <a:ext cx="1598320" cy="13255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5" name="Picture 2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98769" y="1183858"/>
              <a:ext cx="496935" cy="481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7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7089616" y="1579603"/>
              <a:ext cx="502179" cy="93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8" name="Picture 2" descr="S:\Martin\Gewebekultur_Projekt_bessereOrdnung\Bilder\BCE6_Therapie\Pat6_N18_C6\Cet low\Cet_low_ki67.jpg"/>
            <p:cNvPicPr>
              <a:picLocks noChangeAspect="1" noChangeArrowheads="1"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517"/>
            <a:stretch>
              <a:fillRect/>
            </a:stretch>
          </p:blipFill>
          <p:spPr bwMode="auto">
            <a:xfrm>
              <a:off x="7098696" y="3353639"/>
              <a:ext cx="1597008" cy="16074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9" name="Picture 2" descr="S:\Martin\Gewebekultur_Projekt_bessereOrdnung\Bilder\BCE6_Therapie\Pat6_N18_C6\Cet low\Cet_low_EVG.jpg"/>
            <p:cNvPicPr>
              <a:picLocks noChangeAspect="1" noChangeArrowheads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94762" y="1723852"/>
              <a:ext cx="1595698" cy="15943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0" name="Picture 2"/>
            <p:cNvPicPr>
              <a:picLocks noChangeAspect="1" noChangeArrowheads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25861" y="345809"/>
              <a:ext cx="1595698" cy="1316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" name="Picture 2"/>
            <p:cNvPicPr>
              <a:picLocks noChangeAspect="1" noChangeArrowheads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818069" y="1149558"/>
              <a:ext cx="496934" cy="481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2" name="Picture 3" descr="S:\Martin\Gewebekultur_Projekt_bessereOrdnung\Bilder\BCE6_Therapie\Pat6_N18_C6\Pemb high\Pemb_high_EVGh.jpg"/>
            <p:cNvPicPr>
              <a:picLocks noChangeAspect="1" noChangeArrowheads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24550" y="1723852"/>
              <a:ext cx="1597008" cy="15956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5" name="Picture 2" descr="S:\Martin\Gewebekultur_Projekt_bessereOrdnung\Bilder\BCE6_Therapie\Pat6_N18_C6\Pemb high\Pemb_high_ki67.jpg"/>
            <p:cNvPicPr>
              <a:picLocks noChangeAspect="1" noChangeArrowheads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31106" y="3361506"/>
              <a:ext cx="1600942" cy="15996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7" name="Picture 2"/>
            <p:cNvPicPr>
              <a:picLocks noChangeAspect="1" noChangeArrowheads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60894" y="347121"/>
              <a:ext cx="1574576" cy="1328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8" name="Picture 2"/>
            <p:cNvPicPr>
              <a:picLocks noChangeAspect="1" noChangeArrowheads="1"/>
            </p:cNvPicPr>
            <p:nvPr/>
          </p:nvPicPr>
          <p:blipFill>
            <a:blip r:embed="rId3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53046" y="1182298"/>
              <a:ext cx="482566" cy="49304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0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10332048" y="1571308"/>
              <a:ext cx="502179" cy="917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2" name="Picture 2" descr="S:\Martin\Gewebekultur_Projekt_bessereOrdnung\Bilder\BCE6_Therapie\Pat6_N18_C6\Pemblow\Pemb_low_ki67.jpg"/>
            <p:cNvPicPr>
              <a:picLocks noChangeAspect="1" noChangeArrowheads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59583" y="3365440"/>
              <a:ext cx="1597008" cy="15956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4" name="Rechteck 123"/>
            <p:cNvSpPr>
              <a:spLocks noChangeArrowheads="1"/>
            </p:cNvSpPr>
            <p:nvPr/>
          </p:nvSpPr>
          <p:spPr bwMode="auto">
            <a:xfrm>
              <a:off x="7279082" y="99588"/>
              <a:ext cx="12362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Cetuximab 20 nM</a:t>
              </a:r>
            </a:p>
          </p:txBody>
        </p:sp>
        <p:sp>
          <p:nvSpPr>
            <p:cNvPr id="65" name="Rechteck 124"/>
            <p:cNvSpPr>
              <a:spLocks noChangeArrowheads="1"/>
            </p:cNvSpPr>
            <p:nvPr/>
          </p:nvSpPr>
          <p:spPr bwMode="auto">
            <a:xfrm>
              <a:off x="8695704" y="99268"/>
              <a:ext cx="16754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Pembrolizumab 1400 nM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sp>
          <p:nvSpPr>
            <p:cNvPr id="66" name="Rechteck 125"/>
            <p:cNvSpPr>
              <a:spLocks noChangeArrowheads="1"/>
            </p:cNvSpPr>
            <p:nvPr/>
          </p:nvSpPr>
          <p:spPr bwMode="auto">
            <a:xfrm>
              <a:off x="10349314" y="105865"/>
              <a:ext cx="160492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>
                  <a:latin typeface="Arial" panose="020B0604020202020204" pitchFamily="34" charset="0"/>
                </a:rPr>
                <a:t>Pembrolizumab 140 nM</a:t>
              </a:r>
            </a:p>
          </p:txBody>
        </p:sp>
        <p:sp>
          <p:nvSpPr>
            <p:cNvPr id="69" name="Textfeld 68"/>
            <p:cNvSpPr txBox="1"/>
            <p:nvPr/>
          </p:nvSpPr>
          <p:spPr bwMode="auto">
            <a:xfrm>
              <a:off x="2162361" y="1427080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sp>
          <p:nvSpPr>
            <p:cNvPr id="71" name="Textfeld 70"/>
            <p:cNvSpPr txBox="1"/>
            <p:nvPr/>
          </p:nvSpPr>
          <p:spPr bwMode="auto">
            <a:xfrm>
              <a:off x="5427255" y="1429702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sp>
          <p:nvSpPr>
            <p:cNvPr id="72" name="Textfeld 71"/>
            <p:cNvSpPr txBox="1"/>
            <p:nvPr/>
          </p:nvSpPr>
          <p:spPr bwMode="auto">
            <a:xfrm>
              <a:off x="7045945" y="1445345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sp>
          <p:nvSpPr>
            <p:cNvPr id="73" name="Textfeld 72"/>
            <p:cNvSpPr txBox="1"/>
            <p:nvPr/>
          </p:nvSpPr>
          <p:spPr bwMode="auto">
            <a:xfrm>
              <a:off x="8669466" y="1425534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sp>
          <p:nvSpPr>
            <p:cNvPr id="74" name="Textfeld 73"/>
            <p:cNvSpPr txBox="1"/>
            <p:nvPr/>
          </p:nvSpPr>
          <p:spPr bwMode="auto">
            <a:xfrm>
              <a:off x="10274052" y="1424458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grpSp>
          <p:nvGrpSpPr>
            <p:cNvPr id="99" name="Gruppieren 98"/>
            <p:cNvGrpSpPr/>
            <p:nvPr/>
          </p:nvGrpSpPr>
          <p:grpSpPr>
            <a:xfrm>
              <a:off x="11374502" y="1430578"/>
              <a:ext cx="537327" cy="234480"/>
              <a:chOff x="11391127" y="1824907"/>
              <a:chExt cx="537327" cy="234480"/>
            </a:xfrm>
          </p:grpSpPr>
          <p:pic>
            <p:nvPicPr>
              <p:cNvPr id="59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69671" y="2022674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9" name="Textfeld 78"/>
              <p:cNvSpPr txBox="1"/>
              <p:nvPr/>
            </p:nvSpPr>
            <p:spPr bwMode="auto">
              <a:xfrm>
                <a:off x="11391127" y="182490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sp>
          <p:nvSpPr>
            <p:cNvPr id="80" name="Textfeld 79"/>
            <p:cNvSpPr txBox="1"/>
            <p:nvPr/>
          </p:nvSpPr>
          <p:spPr bwMode="auto">
            <a:xfrm>
              <a:off x="3775440" y="1440721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grpSp>
          <p:nvGrpSpPr>
            <p:cNvPr id="3" name="Gruppieren 2"/>
            <p:cNvGrpSpPr/>
            <p:nvPr/>
          </p:nvGrpSpPr>
          <p:grpSpPr>
            <a:xfrm>
              <a:off x="533879" y="3010529"/>
              <a:ext cx="499149" cy="306958"/>
              <a:chOff x="-315777" y="2590973"/>
              <a:chExt cx="499149" cy="306958"/>
            </a:xfrm>
          </p:grpSpPr>
          <p:sp>
            <p:nvSpPr>
              <p:cNvPr id="68" name="Textfeld 67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98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00" name="Gruppieren 99"/>
            <p:cNvGrpSpPr/>
            <p:nvPr/>
          </p:nvGrpSpPr>
          <p:grpSpPr>
            <a:xfrm>
              <a:off x="2183955" y="3010529"/>
              <a:ext cx="499149" cy="306958"/>
              <a:chOff x="-315777" y="2590973"/>
              <a:chExt cx="499149" cy="306958"/>
            </a:xfrm>
          </p:grpSpPr>
          <p:sp>
            <p:nvSpPr>
              <p:cNvPr id="101" name="Textfeld 100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02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03" name="Gruppieren 102"/>
            <p:cNvGrpSpPr/>
            <p:nvPr/>
          </p:nvGrpSpPr>
          <p:grpSpPr>
            <a:xfrm>
              <a:off x="3822104" y="3004940"/>
              <a:ext cx="499149" cy="306958"/>
              <a:chOff x="-315777" y="2590973"/>
              <a:chExt cx="499149" cy="306958"/>
            </a:xfrm>
          </p:grpSpPr>
          <p:sp>
            <p:nvSpPr>
              <p:cNvPr id="104" name="Textfeld 103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05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09" name="Gruppieren 108"/>
            <p:cNvGrpSpPr/>
            <p:nvPr/>
          </p:nvGrpSpPr>
          <p:grpSpPr>
            <a:xfrm>
              <a:off x="5469764" y="3004940"/>
              <a:ext cx="499149" cy="306958"/>
              <a:chOff x="-315777" y="2590973"/>
              <a:chExt cx="499149" cy="306958"/>
            </a:xfrm>
          </p:grpSpPr>
          <p:sp>
            <p:nvSpPr>
              <p:cNvPr id="110" name="Textfeld 109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11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12" name="Gruppieren 111"/>
            <p:cNvGrpSpPr/>
            <p:nvPr/>
          </p:nvGrpSpPr>
          <p:grpSpPr>
            <a:xfrm>
              <a:off x="7089616" y="3004940"/>
              <a:ext cx="499149" cy="306958"/>
              <a:chOff x="-315777" y="2590973"/>
              <a:chExt cx="499149" cy="306958"/>
            </a:xfrm>
          </p:grpSpPr>
          <p:sp>
            <p:nvSpPr>
              <p:cNvPr id="113" name="Textfeld 112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14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15" name="Gruppieren 114"/>
            <p:cNvGrpSpPr/>
            <p:nvPr/>
          </p:nvGrpSpPr>
          <p:grpSpPr>
            <a:xfrm>
              <a:off x="8731106" y="2964772"/>
              <a:ext cx="499149" cy="306958"/>
              <a:chOff x="-315777" y="2590973"/>
              <a:chExt cx="499149" cy="306958"/>
            </a:xfrm>
          </p:grpSpPr>
          <p:sp>
            <p:nvSpPr>
              <p:cNvPr id="116" name="Textfeld 115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17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18" name="Gruppieren 117"/>
            <p:cNvGrpSpPr/>
            <p:nvPr/>
          </p:nvGrpSpPr>
          <p:grpSpPr>
            <a:xfrm>
              <a:off x="10349314" y="2998631"/>
              <a:ext cx="499149" cy="306958"/>
              <a:chOff x="-315777" y="2590973"/>
              <a:chExt cx="499149" cy="306958"/>
            </a:xfrm>
          </p:grpSpPr>
          <p:sp>
            <p:nvSpPr>
              <p:cNvPr id="119" name="Textfeld 118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20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21" name="Gruppieren 120"/>
            <p:cNvGrpSpPr/>
            <p:nvPr/>
          </p:nvGrpSpPr>
          <p:grpSpPr>
            <a:xfrm>
              <a:off x="542340" y="4636187"/>
              <a:ext cx="499149" cy="306958"/>
              <a:chOff x="-315777" y="2590973"/>
              <a:chExt cx="499149" cy="306958"/>
            </a:xfrm>
          </p:grpSpPr>
          <p:sp>
            <p:nvSpPr>
              <p:cNvPr id="122" name="Textfeld 121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23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24" name="Gruppieren 123"/>
            <p:cNvGrpSpPr/>
            <p:nvPr/>
          </p:nvGrpSpPr>
          <p:grpSpPr>
            <a:xfrm>
              <a:off x="2192416" y="4636187"/>
              <a:ext cx="499149" cy="306958"/>
              <a:chOff x="-315777" y="2590973"/>
              <a:chExt cx="499149" cy="306958"/>
            </a:xfrm>
          </p:grpSpPr>
          <p:sp>
            <p:nvSpPr>
              <p:cNvPr id="125" name="Textfeld 124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26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27" name="Gruppieren 126"/>
            <p:cNvGrpSpPr/>
            <p:nvPr/>
          </p:nvGrpSpPr>
          <p:grpSpPr>
            <a:xfrm>
              <a:off x="3830565" y="4630598"/>
              <a:ext cx="499149" cy="306958"/>
              <a:chOff x="-315777" y="2590973"/>
              <a:chExt cx="499149" cy="306958"/>
            </a:xfrm>
          </p:grpSpPr>
          <p:sp>
            <p:nvSpPr>
              <p:cNvPr id="128" name="Textfeld 127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29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30" name="Gruppieren 129"/>
            <p:cNvGrpSpPr/>
            <p:nvPr/>
          </p:nvGrpSpPr>
          <p:grpSpPr>
            <a:xfrm>
              <a:off x="5478225" y="4630598"/>
              <a:ext cx="499149" cy="306958"/>
              <a:chOff x="-315777" y="2590973"/>
              <a:chExt cx="499149" cy="306958"/>
            </a:xfrm>
          </p:grpSpPr>
          <p:sp>
            <p:nvSpPr>
              <p:cNvPr id="131" name="Textfeld 130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32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33" name="Gruppieren 132"/>
            <p:cNvGrpSpPr/>
            <p:nvPr/>
          </p:nvGrpSpPr>
          <p:grpSpPr>
            <a:xfrm>
              <a:off x="7098077" y="4630598"/>
              <a:ext cx="499149" cy="306958"/>
              <a:chOff x="-315777" y="2590973"/>
              <a:chExt cx="499149" cy="306958"/>
            </a:xfrm>
          </p:grpSpPr>
          <p:sp>
            <p:nvSpPr>
              <p:cNvPr id="134" name="Textfeld 133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35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36" name="Gruppieren 135"/>
            <p:cNvGrpSpPr/>
            <p:nvPr/>
          </p:nvGrpSpPr>
          <p:grpSpPr>
            <a:xfrm>
              <a:off x="8739567" y="4590430"/>
              <a:ext cx="499149" cy="306958"/>
              <a:chOff x="-315777" y="2590973"/>
              <a:chExt cx="499149" cy="306958"/>
            </a:xfrm>
          </p:grpSpPr>
          <p:sp>
            <p:nvSpPr>
              <p:cNvPr id="137" name="Textfeld 136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38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39" name="Gruppieren 138"/>
            <p:cNvGrpSpPr/>
            <p:nvPr/>
          </p:nvGrpSpPr>
          <p:grpSpPr>
            <a:xfrm>
              <a:off x="10357775" y="4624289"/>
              <a:ext cx="499149" cy="306958"/>
              <a:chOff x="-315777" y="2590973"/>
              <a:chExt cx="499149" cy="306958"/>
            </a:xfrm>
          </p:grpSpPr>
          <p:sp>
            <p:nvSpPr>
              <p:cNvPr id="140" name="Textfeld 139"/>
              <p:cNvSpPr txBox="1"/>
              <p:nvPr/>
            </p:nvSpPr>
            <p:spPr bwMode="auto">
              <a:xfrm>
                <a:off x="-292753" y="2590973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41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-315777" y="2806417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43" name="Gruppieren 142"/>
            <p:cNvGrpSpPr/>
            <p:nvPr/>
          </p:nvGrpSpPr>
          <p:grpSpPr>
            <a:xfrm>
              <a:off x="9750689" y="1371006"/>
              <a:ext cx="537327" cy="234480"/>
              <a:chOff x="11391127" y="1824907"/>
              <a:chExt cx="537327" cy="234480"/>
            </a:xfrm>
          </p:grpSpPr>
          <p:pic>
            <p:nvPicPr>
              <p:cNvPr id="144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69671" y="2022674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" name="Textfeld 144"/>
              <p:cNvSpPr txBox="1"/>
              <p:nvPr/>
            </p:nvSpPr>
            <p:spPr bwMode="auto">
              <a:xfrm>
                <a:off x="11391127" y="182490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46" name="Gruppieren 145"/>
            <p:cNvGrpSpPr/>
            <p:nvPr/>
          </p:nvGrpSpPr>
          <p:grpSpPr>
            <a:xfrm>
              <a:off x="8134108" y="1410686"/>
              <a:ext cx="537327" cy="234480"/>
              <a:chOff x="11391127" y="1824907"/>
              <a:chExt cx="537327" cy="234480"/>
            </a:xfrm>
          </p:grpSpPr>
          <p:pic>
            <p:nvPicPr>
              <p:cNvPr id="147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69671" y="2022674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8" name="Textfeld 147"/>
              <p:cNvSpPr txBox="1"/>
              <p:nvPr/>
            </p:nvSpPr>
            <p:spPr bwMode="auto">
              <a:xfrm>
                <a:off x="11391127" y="182490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49" name="Gruppieren 148"/>
            <p:cNvGrpSpPr/>
            <p:nvPr/>
          </p:nvGrpSpPr>
          <p:grpSpPr>
            <a:xfrm>
              <a:off x="6520696" y="1396074"/>
              <a:ext cx="537327" cy="234480"/>
              <a:chOff x="11391127" y="1824907"/>
              <a:chExt cx="537327" cy="234480"/>
            </a:xfrm>
          </p:grpSpPr>
          <p:pic>
            <p:nvPicPr>
              <p:cNvPr id="150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69671" y="2022674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1" name="Textfeld 150"/>
              <p:cNvSpPr txBox="1"/>
              <p:nvPr/>
            </p:nvSpPr>
            <p:spPr bwMode="auto">
              <a:xfrm>
                <a:off x="11391127" y="182490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52" name="Gruppieren 151"/>
            <p:cNvGrpSpPr/>
            <p:nvPr/>
          </p:nvGrpSpPr>
          <p:grpSpPr>
            <a:xfrm>
              <a:off x="4878094" y="1395511"/>
              <a:ext cx="537327" cy="234480"/>
              <a:chOff x="11391127" y="1824907"/>
              <a:chExt cx="537327" cy="234480"/>
            </a:xfrm>
          </p:grpSpPr>
          <p:pic>
            <p:nvPicPr>
              <p:cNvPr id="153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69671" y="2022674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4" name="Textfeld 153"/>
              <p:cNvSpPr txBox="1"/>
              <p:nvPr/>
            </p:nvSpPr>
            <p:spPr bwMode="auto">
              <a:xfrm>
                <a:off x="11391127" y="182490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55" name="Gruppieren 154"/>
            <p:cNvGrpSpPr/>
            <p:nvPr/>
          </p:nvGrpSpPr>
          <p:grpSpPr>
            <a:xfrm>
              <a:off x="3209632" y="1412943"/>
              <a:ext cx="537327" cy="234480"/>
              <a:chOff x="11391127" y="1824907"/>
              <a:chExt cx="537327" cy="234480"/>
            </a:xfrm>
          </p:grpSpPr>
          <p:pic>
            <p:nvPicPr>
              <p:cNvPr id="156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69671" y="2022674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7" name="Textfeld 156"/>
              <p:cNvSpPr txBox="1"/>
              <p:nvPr/>
            </p:nvSpPr>
            <p:spPr bwMode="auto">
              <a:xfrm>
                <a:off x="11391127" y="182490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83956" y="5007243"/>
              <a:ext cx="1610986" cy="1432678"/>
            </a:xfrm>
            <a:prstGeom prst="rect">
              <a:avLst/>
            </a:prstGeom>
          </p:spPr>
        </p:pic>
        <p:sp>
          <p:nvSpPr>
            <p:cNvPr id="142" name="Textfeld 141"/>
            <p:cNvSpPr txBox="1"/>
            <p:nvPr/>
          </p:nvSpPr>
          <p:spPr bwMode="auto">
            <a:xfrm>
              <a:off x="2268085" y="6101999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pic>
          <p:nvPicPr>
            <p:cNvPr id="158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2245061" y="6317443"/>
              <a:ext cx="499149" cy="91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0" name="Grafik 159"/>
            <p:cNvPicPr>
              <a:picLocks noChangeAspect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775517" y="6066798"/>
              <a:ext cx="1010980" cy="569203"/>
            </a:xfrm>
            <a:prstGeom prst="rect">
              <a:avLst/>
            </a:prstGeom>
          </p:spPr>
        </p:pic>
        <p:sp>
          <p:nvSpPr>
            <p:cNvPr id="162" name="Textfeld 161"/>
            <p:cNvSpPr txBox="1"/>
            <p:nvPr/>
          </p:nvSpPr>
          <p:spPr bwMode="auto">
            <a:xfrm>
              <a:off x="584414" y="6103037"/>
              <a:ext cx="453970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1 mm</a:t>
              </a:r>
            </a:p>
          </p:txBody>
        </p:sp>
        <p:pic>
          <p:nvPicPr>
            <p:cNvPr id="163" name="Picture 2" descr="S:\Martin\Gewebekultur_Projekt_bessereOrdnung\Bilder\N18.C6\HE_T.jpg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-5045"/>
            <a:stretch>
              <a:fillRect/>
            </a:stretch>
          </p:blipFill>
          <p:spPr bwMode="auto">
            <a:xfrm>
              <a:off x="561390" y="6318481"/>
              <a:ext cx="499149" cy="91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7" name="Picture 4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83336" y="6586996"/>
              <a:ext cx="190120" cy="36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8" name="Textfeld 167"/>
            <p:cNvSpPr txBox="1"/>
            <p:nvPr/>
          </p:nvSpPr>
          <p:spPr bwMode="auto">
            <a:xfrm>
              <a:off x="2691565" y="6408265"/>
              <a:ext cx="537327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250 µm</a:t>
              </a:r>
            </a:p>
          </p:txBody>
        </p:sp>
        <p:pic>
          <p:nvPicPr>
            <p:cNvPr id="170" name="Picture 4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4836" y="6577471"/>
              <a:ext cx="190120" cy="36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2" name="Rechteck 73"/>
            <p:cNvSpPr>
              <a:spLocks noChangeArrowheads="1"/>
            </p:cNvSpPr>
            <p:nvPr/>
          </p:nvSpPr>
          <p:spPr bwMode="auto">
            <a:xfrm rot="16200000">
              <a:off x="93077" y="5574681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fontAlgn="b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 err="1" smtClean="0">
                  <a:latin typeface="Arial" panose="020B0604020202020204" pitchFamily="34" charset="0"/>
                </a:rPr>
                <a:t>Casp</a:t>
              </a:r>
              <a:r>
                <a:rPr lang="de-DE" altLang="de-DE" sz="1000" b="1" dirty="0" smtClean="0">
                  <a:latin typeface="Arial" panose="020B0604020202020204" pitchFamily="34" charset="0"/>
                </a:rPr>
                <a:t> 3</a:t>
              </a:r>
              <a:endPara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</p:txBody>
        </p:sp>
        <p:pic>
          <p:nvPicPr>
            <p:cNvPr id="173" name="Grafik 172"/>
            <p:cNvPicPr>
              <a:picLocks noChangeAspect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26760" y="5008449"/>
              <a:ext cx="1602489" cy="1430451"/>
            </a:xfrm>
            <a:prstGeom prst="rect">
              <a:avLst/>
            </a:prstGeom>
          </p:spPr>
        </p:pic>
        <p:pic>
          <p:nvPicPr>
            <p:cNvPr id="174" name="Grafik 173"/>
            <p:cNvPicPr>
              <a:picLocks noChangeAspect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07887" y="6069673"/>
              <a:ext cx="1010264" cy="568800"/>
            </a:xfrm>
            <a:prstGeom prst="rect">
              <a:avLst/>
            </a:prstGeom>
          </p:spPr>
        </p:pic>
        <p:pic>
          <p:nvPicPr>
            <p:cNvPr id="175" name="Grafik 174"/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62043" y="5008449"/>
              <a:ext cx="1612239" cy="1432027"/>
            </a:xfrm>
            <a:prstGeom prst="rect">
              <a:avLst/>
            </a:prstGeom>
          </p:spPr>
        </p:pic>
        <p:pic>
          <p:nvPicPr>
            <p:cNvPr id="176" name="Grafik 175"/>
            <p:cNvPicPr>
              <a:picLocks noChangeAspect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49630" y="6062832"/>
              <a:ext cx="1010265" cy="568800"/>
            </a:xfrm>
            <a:prstGeom prst="rect">
              <a:avLst/>
            </a:prstGeom>
          </p:spPr>
        </p:pic>
        <p:pic>
          <p:nvPicPr>
            <p:cNvPr id="177" name="Grafik 176"/>
            <p:cNvPicPr>
              <a:picLocks noChangeAspect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099124" y="5013122"/>
              <a:ext cx="1594026" cy="1429779"/>
            </a:xfrm>
            <a:prstGeom prst="rect">
              <a:avLst/>
            </a:prstGeom>
          </p:spPr>
        </p:pic>
        <p:pic>
          <p:nvPicPr>
            <p:cNvPr id="178" name="Grafik 177"/>
            <p:cNvPicPr>
              <a:picLocks noChangeAspect="1"/>
            </p:cNvPicPr>
            <p:nvPr/>
          </p:nvPicPr>
          <p:blipFill>
            <a:blip r:embed="rId4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661712" y="6059576"/>
              <a:ext cx="1010264" cy="568800"/>
            </a:xfrm>
            <a:prstGeom prst="rect">
              <a:avLst/>
            </a:prstGeom>
          </p:spPr>
        </p:pic>
        <p:pic>
          <p:nvPicPr>
            <p:cNvPr id="179" name="Grafik 178"/>
            <p:cNvPicPr>
              <a:picLocks noChangeAspect="1"/>
            </p:cNvPicPr>
            <p:nvPr/>
          </p:nvPicPr>
          <p:blipFill rotWithShape="1">
            <a:blip r:embed="rId4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732044" y="5003094"/>
              <a:ext cx="1608296" cy="1437273"/>
            </a:xfrm>
            <a:prstGeom prst="rect">
              <a:avLst/>
            </a:prstGeom>
          </p:spPr>
        </p:pic>
        <p:pic>
          <p:nvPicPr>
            <p:cNvPr id="180" name="Grafik 179"/>
            <p:cNvPicPr>
              <a:picLocks noChangeAspect="1"/>
            </p:cNvPicPr>
            <p:nvPr/>
          </p:nvPicPr>
          <p:blipFill>
            <a:blip r:embed="rId4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316858" y="6057356"/>
              <a:ext cx="1010265" cy="568800"/>
            </a:xfrm>
            <a:prstGeom prst="rect">
              <a:avLst/>
            </a:prstGeom>
          </p:spPr>
        </p:pic>
        <p:pic>
          <p:nvPicPr>
            <p:cNvPr id="181" name="Grafik 180"/>
            <p:cNvPicPr>
              <a:picLocks noChangeAspect="1"/>
            </p:cNvPicPr>
            <p:nvPr/>
          </p:nvPicPr>
          <p:blipFill rotWithShape="1">
            <a:blip r:embed="rId4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358052" y="5006909"/>
              <a:ext cx="1600586" cy="1427089"/>
            </a:xfrm>
            <a:prstGeom prst="rect">
              <a:avLst/>
            </a:prstGeom>
          </p:spPr>
        </p:pic>
        <p:pic>
          <p:nvPicPr>
            <p:cNvPr id="182" name="Grafik 181"/>
            <p:cNvPicPr>
              <a:picLocks noChangeAspect="1"/>
            </p:cNvPicPr>
            <p:nvPr/>
          </p:nvPicPr>
          <p:blipFill>
            <a:blip r:embed="rId4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939907" y="6059655"/>
              <a:ext cx="1010265" cy="568800"/>
            </a:xfrm>
            <a:prstGeom prst="rect">
              <a:avLst/>
            </a:prstGeom>
          </p:spPr>
        </p:pic>
        <p:grpSp>
          <p:nvGrpSpPr>
            <p:cNvPr id="13" name="Gruppieren 12"/>
            <p:cNvGrpSpPr/>
            <p:nvPr/>
          </p:nvGrpSpPr>
          <p:grpSpPr>
            <a:xfrm>
              <a:off x="3893098" y="6152252"/>
              <a:ext cx="992846" cy="468288"/>
              <a:chOff x="3893098" y="6152252"/>
              <a:chExt cx="992846" cy="468288"/>
            </a:xfrm>
          </p:grpSpPr>
          <p:sp>
            <p:nvSpPr>
              <p:cNvPr id="183" name="Textfeld 182"/>
              <p:cNvSpPr txBox="1"/>
              <p:nvPr/>
            </p:nvSpPr>
            <p:spPr bwMode="auto">
              <a:xfrm>
                <a:off x="3916123" y="6152252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84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3893098" y="6310548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5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33680" y="6583827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86" name="Textfeld 185"/>
              <p:cNvSpPr txBox="1"/>
              <p:nvPr/>
            </p:nvSpPr>
            <p:spPr bwMode="auto">
              <a:xfrm>
                <a:off x="4348617" y="639796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87" name="Gruppieren 186"/>
            <p:cNvGrpSpPr/>
            <p:nvPr/>
          </p:nvGrpSpPr>
          <p:grpSpPr>
            <a:xfrm>
              <a:off x="5521878" y="6152245"/>
              <a:ext cx="992846" cy="468288"/>
              <a:chOff x="3893098" y="6152252"/>
              <a:chExt cx="992846" cy="468288"/>
            </a:xfrm>
          </p:grpSpPr>
          <p:sp>
            <p:nvSpPr>
              <p:cNvPr id="188" name="Textfeld 187"/>
              <p:cNvSpPr txBox="1"/>
              <p:nvPr/>
            </p:nvSpPr>
            <p:spPr bwMode="auto">
              <a:xfrm>
                <a:off x="3916123" y="6152252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89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3893098" y="6310548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0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33680" y="6583827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1" name="Textfeld 190"/>
              <p:cNvSpPr txBox="1"/>
              <p:nvPr/>
            </p:nvSpPr>
            <p:spPr bwMode="auto">
              <a:xfrm>
                <a:off x="4348617" y="639796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92" name="Gruppieren 191"/>
            <p:cNvGrpSpPr/>
            <p:nvPr/>
          </p:nvGrpSpPr>
          <p:grpSpPr>
            <a:xfrm>
              <a:off x="7145898" y="6147478"/>
              <a:ext cx="992846" cy="468288"/>
              <a:chOff x="3893098" y="6152252"/>
              <a:chExt cx="992846" cy="468288"/>
            </a:xfrm>
          </p:grpSpPr>
          <p:sp>
            <p:nvSpPr>
              <p:cNvPr id="193" name="Textfeld 192"/>
              <p:cNvSpPr txBox="1"/>
              <p:nvPr/>
            </p:nvSpPr>
            <p:spPr bwMode="auto">
              <a:xfrm>
                <a:off x="3916123" y="6152252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94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3893098" y="6310548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5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33680" y="6583827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6" name="Textfeld 195"/>
              <p:cNvSpPr txBox="1"/>
              <p:nvPr/>
            </p:nvSpPr>
            <p:spPr bwMode="auto">
              <a:xfrm>
                <a:off x="4348617" y="639796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197" name="Gruppieren 196"/>
            <p:cNvGrpSpPr/>
            <p:nvPr/>
          </p:nvGrpSpPr>
          <p:grpSpPr>
            <a:xfrm>
              <a:off x="8803258" y="6147472"/>
              <a:ext cx="992846" cy="468288"/>
              <a:chOff x="3893098" y="6152252"/>
              <a:chExt cx="992846" cy="468288"/>
            </a:xfrm>
          </p:grpSpPr>
          <p:sp>
            <p:nvSpPr>
              <p:cNvPr id="198" name="Textfeld 197"/>
              <p:cNvSpPr txBox="1"/>
              <p:nvPr/>
            </p:nvSpPr>
            <p:spPr bwMode="auto">
              <a:xfrm>
                <a:off x="3916123" y="6152252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199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3893098" y="6310548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0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33680" y="6583827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1" name="Textfeld 200"/>
              <p:cNvSpPr txBox="1"/>
              <p:nvPr/>
            </p:nvSpPr>
            <p:spPr bwMode="auto">
              <a:xfrm>
                <a:off x="4348617" y="639796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grpSp>
          <p:nvGrpSpPr>
            <p:cNvPr id="202" name="Gruppieren 201"/>
            <p:cNvGrpSpPr/>
            <p:nvPr/>
          </p:nvGrpSpPr>
          <p:grpSpPr>
            <a:xfrm>
              <a:off x="10441570" y="6142703"/>
              <a:ext cx="992846" cy="468288"/>
              <a:chOff x="3893098" y="6152252"/>
              <a:chExt cx="992846" cy="468288"/>
            </a:xfrm>
          </p:grpSpPr>
          <p:sp>
            <p:nvSpPr>
              <p:cNvPr id="203" name="Textfeld 202"/>
              <p:cNvSpPr txBox="1"/>
              <p:nvPr/>
            </p:nvSpPr>
            <p:spPr bwMode="auto">
              <a:xfrm>
                <a:off x="3916123" y="6152252"/>
                <a:ext cx="453970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1 mm</a:t>
                </a:r>
              </a:p>
            </p:txBody>
          </p:sp>
          <p:pic>
            <p:nvPicPr>
              <p:cNvPr id="204" name="Picture 2" descr="S:\Martin\Gewebekultur_Projekt_bessereOrdnung\Bilder\N18.C6\HE_T.jpg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-5045"/>
              <a:stretch>
                <a:fillRect/>
              </a:stretch>
            </p:blipFill>
            <p:spPr bwMode="auto">
              <a:xfrm>
                <a:off x="3893098" y="6310548"/>
                <a:ext cx="499149" cy="915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5" name="Picture 4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33680" y="6583827"/>
                <a:ext cx="190120" cy="36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6" name="Textfeld 205"/>
              <p:cNvSpPr txBox="1"/>
              <p:nvPr/>
            </p:nvSpPr>
            <p:spPr bwMode="auto">
              <a:xfrm>
                <a:off x="4348617" y="6397967"/>
                <a:ext cx="537327" cy="21544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de-DE" sz="800" b="1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</a:rPr>
                  <a:t>250 µm</a:t>
                </a:r>
              </a:p>
            </p:txBody>
          </p:sp>
        </p:grpSp>
        <p:sp>
          <p:nvSpPr>
            <p:cNvPr id="171" name="Textfeld 170"/>
            <p:cNvSpPr txBox="1"/>
            <p:nvPr/>
          </p:nvSpPr>
          <p:spPr bwMode="auto">
            <a:xfrm>
              <a:off x="1053065" y="6398740"/>
              <a:ext cx="537327" cy="21544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de-DE" sz="8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</a:rPr>
                <a:t>250 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04608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Breitbild</PresentationFormat>
  <Paragraphs>5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, Steve Zacharias</dc:creator>
  <cp:lastModifiedBy>Martin, Steve Zacharias</cp:lastModifiedBy>
  <cp:revision>15</cp:revision>
  <dcterms:created xsi:type="dcterms:W3CDTF">2019-04-10T11:31:01Z</dcterms:created>
  <dcterms:modified xsi:type="dcterms:W3CDTF">2019-09-17T16:43:15Z</dcterms:modified>
</cp:coreProperties>
</file>